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  <p:sldMasterId id="2147483662" r:id="rId2"/>
  </p:sldMasterIdLst>
  <p:sldIdLst>
    <p:sldId id="268" r:id="rId3"/>
    <p:sldId id="269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1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伊勢 真人" userId="979f6958fffc315b" providerId="LiveId" clId="{357C1E26-C838-4256-8DE0-E1199B95C5AB}"/>
    <pc:docChg chg="addSld delSld modSld addMainMaster modMainMaster">
      <pc:chgData name="伊勢 真人" userId="979f6958fffc315b" providerId="LiveId" clId="{357C1E26-C838-4256-8DE0-E1199B95C5AB}" dt="2021-07-19T10:51:32.371" v="6" actId="47"/>
      <pc:docMkLst>
        <pc:docMk/>
      </pc:docMkLst>
      <pc:sldChg chg="modSp new del">
        <pc:chgData name="伊勢 真人" userId="979f6958fffc315b" providerId="LiveId" clId="{357C1E26-C838-4256-8DE0-E1199B95C5AB}" dt="2021-07-19T10:51:31.811" v="5" actId="47"/>
        <pc:sldMkLst>
          <pc:docMk/>
          <pc:sldMk cId="2027679683" sldId="256"/>
        </pc:sldMkLst>
        <pc:spChg chg="mod">
          <ac:chgData name="伊勢 真人" userId="979f6958fffc315b" providerId="LiveId" clId="{357C1E26-C838-4256-8DE0-E1199B95C5AB}" dt="2021-07-19T10:51:22.040" v="2"/>
          <ac:spMkLst>
            <pc:docMk/>
            <pc:sldMk cId="2027679683" sldId="256"/>
            <ac:spMk id="2" creationId="{73828F91-932D-4602-8EC6-3C4BB6AA5065}"/>
          </ac:spMkLst>
        </pc:spChg>
        <pc:spChg chg="mod">
          <ac:chgData name="伊勢 真人" userId="979f6958fffc315b" providerId="LiveId" clId="{357C1E26-C838-4256-8DE0-E1199B95C5AB}" dt="2021-07-19T10:51:22.040" v="2"/>
          <ac:spMkLst>
            <pc:docMk/>
            <pc:sldMk cId="2027679683" sldId="256"/>
            <ac:spMk id="3" creationId="{D4C1E66E-5B5A-4A36-8219-72B23D797A58}"/>
          </ac:spMkLst>
        </pc:spChg>
      </pc:sldChg>
      <pc:sldChg chg="new del">
        <pc:chgData name="伊勢 真人" userId="979f6958fffc315b" providerId="LiveId" clId="{357C1E26-C838-4256-8DE0-E1199B95C5AB}" dt="2021-07-19T10:51:32.371" v="6" actId="47"/>
        <pc:sldMkLst>
          <pc:docMk/>
          <pc:sldMk cId="1255790804" sldId="257"/>
        </pc:sldMkLst>
      </pc:sldChg>
      <pc:sldChg chg="add">
        <pc:chgData name="伊勢 真人" userId="979f6958fffc315b" providerId="LiveId" clId="{357C1E26-C838-4256-8DE0-E1199B95C5AB}" dt="2021-07-19T10:51:29.177" v="4"/>
        <pc:sldMkLst>
          <pc:docMk/>
          <pc:sldMk cId="777919724" sldId="268"/>
        </pc:sldMkLst>
      </pc:sldChg>
      <pc:sldChg chg="modSp add">
        <pc:chgData name="伊勢 真人" userId="979f6958fffc315b" providerId="LiveId" clId="{357C1E26-C838-4256-8DE0-E1199B95C5AB}" dt="2021-07-19T10:51:29.177" v="4"/>
        <pc:sldMkLst>
          <pc:docMk/>
          <pc:sldMk cId="2779879439" sldId="269"/>
        </pc:sldMkLst>
        <pc:graphicFrameChg chg="mod">
          <ac:chgData name="伊勢 真人" userId="979f6958fffc315b" providerId="LiveId" clId="{357C1E26-C838-4256-8DE0-E1199B95C5AB}" dt="2021-07-19T10:51:29.177" v="4"/>
          <ac:graphicFrameMkLst>
            <pc:docMk/>
            <pc:sldMk cId="2779879439" sldId="269"/>
            <ac:graphicFrameMk id="4" creationId="{666526A1-FBC8-4EF5-976C-FB689675E55A}"/>
          </ac:graphicFrameMkLst>
        </pc:graphicFrameChg>
        <pc:graphicFrameChg chg="mod">
          <ac:chgData name="伊勢 真人" userId="979f6958fffc315b" providerId="LiveId" clId="{357C1E26-C838-4256-8DE0-E1199B95C5AB}" dt="2021-07-19T10:51:29.177" v="4"/>
          <ac:graphicFrameMkLst>
            <pc:docMk/>
            <pc:sldMk cId="2779879439" sldId="269"/>
            <ac:graphicFrameMk id="5" creationId="{C8E9CA7C-E8CE-49B4-91F6-D475E171DA9C}"/>
          </ac:graphicFrameMkLst>
        </pc:graphicFrameChg>
      </pc:sldChg>
      <pc:sldMasterChg chg="addSldLayout">
        <pc:chgData name="伊勢 真人" userId="979f6958fffc315b" providerId="LiveId" clId="{357C1E26-C838-4256-8DE0-E1199B95C5AB}" dt="2021-07-19T10:50:47.781" v="0" actId="680"/>
        <pc:sldMasterMkLst>
          <pc:docMk/>
          <pc:sldMasterMk cId="3027820562" sldId="2147483648"/>
        </pc:sldMasterMkLst>
        <pc:sldLayoutChg chg="add">
          <pc:chgData name="伊勢 真人" userId="979f6958fffc315b" providerId="LiveId" clId="{357C1E26-C838-4256-8DE0-E1199B95C5AB}" dt="2021-07-19T10:50:47.781" v="0" actId="680"/>
          <pc:sldLayoutMkLst>
            <pc:docMk/>
            <pc:sldMasterMk cId="3027820562" sldId="2147483648"/>
            <pc:sldLayoutMk cId="1686289354" sldId="2147483649"/>
          </pc:sldLayoutMkLst>
        </pc:sldLayoutChg>
      </pc:sldMasterChg>
      <pc:sldMasterChg chg="new mod addSldLayout">
        <pc:chgData name="伊勢 真人" userId="979f6958fffc315b" providerId="LiveId" clId="{357C1E26-C838-4256-8DE0-E1199B95C5AB}" dt="2021-07-19T10:51:12.932" v="1" actId="6938"/>
        <pc:sldMasterMkLst>
          <pc:docMk/>
          <pc:sldMasterMk cId="2876689067" sldId="2147483650"/>
        </pc:sldMasterMkLst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1861619880" sldId="2147483651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1816016573" sldId="2147483652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2653563601" sldId="2147483653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3879120152" sldId="2147483654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2236538256" sldId="2147483655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3561030768" sldId="2147483656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2631294550" sldId="2147483657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3599780338" sldId="2147483658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2582751151" sldId="2147483659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559844529" sldId="2147483660"/>
          </pc:sldLayoutMkLst>
        </pc:sldLayoutChg>
        <pc:sldLayoutChg chg="new replId">
          <pc:chgData name="伊勢 真人" userId="979f6958fffc315b" providerId="LiveId" clId="{357C1E26-C838-4256-8DE0-E1199B95C5AB}" dt="2021-07-19T10:51:12.932" v="1" actId="6938"/>
          <pc:sldLayoutMkLst>
            <pc:docMk/>
            <pc:sldMasterMk cId="2876689067" sldId="2147483650"/>
            <pc:sldLayoutMk cId="1793593884" sldId="214748366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705E9F-05AA-4475-AA42-7E9FF937D8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B813A0B-6141-4E68-97E5-CB13C2E3DC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050623-FF7E-4314-9702-0DB2E1042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BDB2D7-A2B0-41E9-BA47-6F2F20EC3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5996F3-29D5-4862-9B86-0F7DCA035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619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9ACA70-9BBF-4B7D-A529-01099632D4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B86F418-A81E-433F-9B95-23AFB080DC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C94668-896C-4EFF-8AAE-B369EC5F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1E7A00-6B85-4712-A9B9-188549976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D096C9-C3E0-4C73-956E-88C94CBB6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844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6C87553-A35B-4DE4-8761-7E8B624BF1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FF80781-8747-4B41-ADEC-8D30F6C98D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775EB2-8BAF-484F-AF8D-F9C8FE949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12B2A9-9634-4A84-BF6D-36296A54F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1E5294-7AF7-4A05-8F11-A6904D8BB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5938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92305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43308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39247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69578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92833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59812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785332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818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AAB033-53A4-45B7-B990-9E53421F6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6F55EC-A921-4B96-B061-B2F95EA30B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E34485-2170-4955-A578-C604F76CE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8EE3BC-FF1D-4230-BC94-2C0FA386D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00D78D-3962-45DE-8647-C14AD1F1E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01657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23894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598562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784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2BF1D6-8FB5-4C30-B8AE-086D58CA5D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36FF581-84CC-454D-BC6F-BC6A4D8260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868192-8DD2-4D85-A1BF-F72A153DC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58396E-E243-4D68-BF4C-0807ED747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FFC0DE-3D8B-4229-8E78-67652812C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563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23C040-05D2-420D-A5FF-F2B710D95A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B1B454B-6920-4EE1-A00D-4E0BA0925F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BA6489-89BA-4A84-A9D9-6798F896C2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E9CF589-A688-4077-9F95-7E824563C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C8555D-24F5-4D62-9209-5593D34C7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35A170-16A8-4BDA-991D-39DEC3BD2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120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F43EB9-845E-4BD8-9097-67CDB8C60B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57612D-36ED-42FE-A49B-237F686126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C055CB-A32C-4CFB-A385-D54B73279F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F1054F-592A-4814-AFD8-92F1D64226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883FB1-FD94-4C61-B17E-386276393F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7E98F0E-0AD3-420B-9F2C-B38169D76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C2FDA8-CDFB-46E0-B834-9D88F8539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9E3368E-58CD-46C9-A30B-14BA13584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538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4D8FDA-D6C3-4752-86D8-768920F68E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2F8C74B-FC1D-4651-8AD9-7C67F0CF3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2CDF453-8DD5-4349-B7F8-49AAD4244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6B4F95C-B3CC-4ADB-99FB-C8FE48DE3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1030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B75BA66-6A90-42F6-B22D-4A93E5FF2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C42F8C5-0922-49F7-8818-BB1555AA9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20984D5-03DF-43F8-A8B6-19D355B6B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294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836905-1027-4DE2-878E-45DDA6299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758AFB-8D2B-42C7-8170-858C45D086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F5DF90D-00FF-4BC0-B409-56F62038D9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6C4D9E3-B989-4321-A500-C94402E23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089B01-C54B-4825-B80C-BDF8CC379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826013-89ED-40CC-B9D3-71A4DC43E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78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A276A7-6EBD-4C6A-AA54-0DD261DA8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E162EBF-3FD1-4A9F-A961-77658178E8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1FB5094-8845-4D57-8126-80187E8265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E0E9E63-0900-4350-B2BF-4FCA82996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1D2F9D-0227-4613-9AF8-E2D8012D7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0556A9-0EC9-46B3-BFB4-A131F2A18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751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2CF7B92-352B-436B-BE70-2B4AE643E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B17A37D-CFFB-4233-B3FF-480E17421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F5AB6C-1BEB-4E13-930C-94C8B64270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94A2AE-4C49-4ACF-876A-F693DA6FFF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4F5861-48BD-45AB-A405-753225EF80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689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BF4AF-4C3B-4795-981D-CFC74D2DE876}" type="datetimeFigureOut">
              <a:rPr kumimoji="1" lang="ja-JP" altLang="en-US" smtClean="0"/>
              <a:t>2021/7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15780-568A-4431-BE5A-481996406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58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65" r:id="rId3"/>
    <p:sldLayoutId id="2147483666" r:id="rId4"/>
    <p:sldLayoutId id="2147483667" r:id="rId5"/>
    <p:sldLayoutId id="2147483668" r:id="rId6"/>
    <p:sldLayoutId id="2147483669" r:id="rId7"/>
    <p:sldLayoutId id="2147483670" r:id="rId8"/>
    <p:sldLayoutId id="2147483671" r:id="rId9"/>
    <p:sldLayoutId id="2147483672" r:id="rId10"/>
    <p:sldLayoutId id="214748367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66526A1-FBC8-4EF5-976C-FB689675E55A}"/>
              </a:ext>
            </a:extLst>
          </p:cNvPr>
          <p:cNvGraphicFramePr>
            <a:graphicFrameLocks noGrp="1"/>
          </p:cNvGraphicFramePr>
          <p:nvPr/>
        </p:nvGraphicFramePr>
        <p:xfrm>
          <a:off x="309378" y="1707579"/>
          <a:ext cx="5785505" cy="805814"/>
        </p:xfrm>
        <a:graphic>
          <a:graphicData uri="http://schemas.openxmlformats.org/drawingml/2006/table">
            <a:tbl>
              <a:tblPr/>
              <a:tblGrid>
                <a:gridCol w="1444625">
                  <a:extLst>
                    <a:ext uri="{9D8B030D-6E8A-4147-A177-3AD203B41FA5}">
                      <a16:colId xmlns:a16="http://schemas.microsoft.com/office/drawing/2014/main" val="3131499652"/>
                    </a:ext>
                  </a:extLst>
                </a:gridCol>
                <a:gridCol w="1396190">
                  <a:extLst>
                    <a:ext uri="{9D8B030D-6E8A-4147-A177-3AD203B41FA5}">
                      <a16:colId xmlns:a16="http://schemas.microsoft.com/office/drawing/2014/main" val="1839387401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520057376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279003019"/>
                    </a:ext>
                  </a:extLst>
                </a:gridCol>
              </a:tblGrid>
              <a:tr h="3295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6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-12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12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376271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reoperative CMAP &lt; 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8 (5.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8 (2.0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.7 (8.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25738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reoperative CMAP </a:t>
                      </a:r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6 (3.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9 (2.3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.7 (3.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43467987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8E9CA7C-E8CE-49B4-91F6-D475E171DA9C}"/>
              </a:ext>
            </a:extLst>
          </p:cNvPr>
          <p:cNvGraphicFramePr>
            <a:graphicFrameLocks noGrp="1"/>
          </p:cNvGraphicFramePr>
          <p:nvPr/>
        </p:nvGraphicFramePr>
        <p:xfrm>
          <a:off x="309379" y="2649807"/>
          <a:ext cx="5810906" cy="903042"/>
        </p:xfrm>
        <a:graphic>
          <a:graphicData uri="http://schemas.openxmlformats.org/drawingml/2006/table">
            <a:tbl>
              <a:tblPr/>
              <a:tblGrid>
                <a:gridCol w="1470026">
                  <a:extLst>
                    <a:ext uri="{9D8B030D-6E8A-4147-A177-3AD203B41FA5}">
                      <a16:colId xmlns:a16="http://schemas.microsoft.com/office/drawing/2014/main" val="616369425"/>
                    </a:ext>
                  </a:extLst>
                </a:gridCol>
                <a:gridCol w="1396190">
                  <a:extLst>
                    <a:ext uri="{9D8B030D-6E8A-4147-A177-3AD203B41FA5}">
                      <a16:colId xmlns:a16="http://schemas.microsoft.com/office/drawing/2014/main" val="602065470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1220642007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1022298259"/>
                    </a:ext>
                  </a:extLst>
                </a:gridCol>
              </a:tblGrid>
              <a:tr h="489584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6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-12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12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248042"/>
                  </a:ext>
                </a:extLst>
              </a:tr>
              <a:tr h="20672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reoperative CMAP &lt; 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.2 (16.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.9 (14.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.6 (17.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5447652"/>
                  </a:ext>
                </a:extLst>
              </a:tr>
              <a:tr h="206729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reoperative CMAP </a:t>
                      </a:r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8.8 (14.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1 (9.0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.2 (10.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7695268"/>
                  </a:ext>
                </a:extLst>
              </a:tr>
            </a:tbl>
          </a:graphicData>
        </a:graphic>
      </p:graphicFrame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40658DFE-7238-4E0E-97C4-AF996F45B75E}"/>
              </a:ext>
            </a:extLst>
          </p:cNvPr>
          <p:cNvSpPr txBox="1"/>
          <p:nvPr/>
        </p:nvSpPr>
        <p:spPr>
          <a:xfrm>
            <a:off x="190634" y="967167"/>
            <a:ext cx="5761812" cy="681992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</a:t>
            </a:r>
          </a:p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average difference of grip strength and DASH between two groups divided by the lower limit of preoperative CMAP amplitudes. </a:t>
            </a:r>
          </a:p>
        </p:txBody>
      </p:sp>
      <p:sp>
        <p:nvSpPr>
          <p:cNvPr id="8" name="テキスト ボックス 2">
            <a:extLst>
              <a:ext uri="{FF2B5EF4-FFF2-40B4-BE49-F238E27FC236}">
                <a16:creationId xmlns:a16="http://schemas.microsoft.com/office/drawing/2014/main" id="{087A5378-5344-4DA2-A2FE-E6B8980F742D}"/>
              </a:ext>
            </a:extLst>
          </p:cNvPr>
          <p:cNvSpPr txBox="1"/>
          <p:nvPr/>
        </p:nvSpPr>
        <p:spPr>
          <a:xfrm>
            <a:off x="190634" y="3805005"/>
            <a:ext cx="2855594" cy="275590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/>
              <a:t>* </a:t>
            </a:r>
            <a:r>
              <a:rPr lang="en-US" altLang="ja-JP" sz="1050" i="1" dirty="0">
                <a:latin typeface="Times" panose="02020603050405020304" pitchFamily="18" charset="0"/>
                <a:cs typeface="Times" panose="02020603050405020304" pitchFamily="18" charset="0"/>
              </a:rPr>
              <a:t>P</a:t>
            </a:r>
            <a:r>
              <a:rPr lang="en-US" altLang="ja-JP" sz="1050" dirty="0">
                <a:latin typeface="Times" panose="02020603050405020304" pitchFamily="18" charset="0"/>
                <a:cs typeface="Times" panose="02020603050405020304" pitchFamily="18" charset="0"/>
              </a:rPr>
              <a:t>&lt;0.05,**</a:t>
            </a:r>
            <a:r>
              <a:rPr lang="en-US" altLang="ja-JP" sz="1050" i="1" dirty="0">
                <a:latin typeface="Times" panose="02020603050405020304" pitchFamily="18" charset="0"/>
                <a:cs typeface="Times" panose="02020603050405020304" pitchFamily="18" charset="0"/>
              </a:rPr>
              <a:t>P</a:t>
            </a:r>
            <a:r>
              <a:rPr lang="en-US" altLang="ja-JP" sz="1050" dirty="0">
                <a:latin typeface="Times" panose="02020603050405020304" pitchFamily="18" charset="0"/>
                <a:cs typeface="Times" panose="02020603050405020304" pitchFamily="18" charset="0"/>
              </a:rPr>
              <a:t>&lt;0.01; </a:t>
            </a:r>
            <a:r>
              <a:rPr lang="en-US" altLang="ja-JP" sz="1050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nn–Whitney </a:t>
            </a:r>
            <a:r>
              <a:rPr lang="en-US" altLang="ja-JP" sz="1050" b="1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en-US" altLang="ja-JP" sz="1050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test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05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919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666526A1-FBC8-4EF5-976C-FB689675E55A}"/>
              </a:ext>
            </a:extLst>
          </p:cNvPr>
          <p:cNvGraphicFramePr>
            <a:graphicFrameLocks noGrp="1"/>
          </p:cNvGraphicFramePr>
          <p:nvPr/>
        </p:nvGraphicFramePr>
        <p:xfrm>
          <a:off x="309379" y="1707579"/>
          <a:ext cx="5837894" cy="805815"/>
        </p:xfrm>
        <a:graphic>
          <a:graphicData uri="http://schemas.openxmlformats.org/drawingml/2006/table">
            <a:tbl>
              <a:tblPr/>
              <a:tblGrid>
                <a:gridCol w="1497014">
                  <a:extLst>
                    <a:ext uri="{9D8B030D-6E8A-4147-A177-3AD203B41FA5}">
                      <a16:colId xmlns:a16="http://schemas.microsoft.com/office/drawing/2014/main" val="3131499652"/>
                    </a:ext>
                  </a:extLst>
                </a:gridCol>
                <a:gridCol w="1396190">
                  <a:extLst>
                    <a:ext uri="{9D8B030D-6E8A-4147-A177-3AD203B41FA5}">
                      <a16:colId xmlns:a16="http://schemas.microsoft.com/office/drawing/2014/main" val="1839387401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520057376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279003019"/>
                    </a:ext>
                  </a:extLst>
                </a:gridCol>
              </a:tblGrid>
              <a:tr h="3295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6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-12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12 Difference of G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3762717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ostoperative CMAP &lt; 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-0.1 (3.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5 (1.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.0 (3.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25738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ostoperative CMAP </a:t>
                      </a:r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0 (5.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.3 (2.4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.8 (10.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43467987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8E9CA7C-E8CE-49B4-91F6-D475E171DA9C}"/>
              </a:ext>
            </a:extLst>
          </p:cNvPr>
          <p:cNvGraphicFramePr>
            <a:graphicFrameLocks noGrp="1"/>
          </p:cNvGraphicFramePr>
          <p:nvPr/>
        </p:nvGraphicFramePr>
        <p:xfrm>
          <a:off x="309379" y="2649807"/>
          <a:ext cx="5863293" cy="903042"/>
        </p:xfrm>
        <a:graphic>
          <a:graphicData uri="http://schemas.openxmlformats.org/drawingml/2006/table">
            <a:tbl>
              <a:tblPr/>
              <a:tblGrid>
                <a:gridCol w="1522413">
                  <a:extLst>
                    <a:ext uri="{9D8B030D-6E8A-4147-A177-3AD203B41FA5}">
                      <a16:colId xmlns:a16="http://schemas.microsoft.com/office/drawing/2014/main" val="616369425"/>
                    </a:ext>
                  </a:extLst>
                </a:gridCol>
                <a:gridCol w="1396190">
                  <a:extLst>
                    <a:ext uri="{9D8B030D-6E8A-4147-A177-3AD203B41FA5}">
                      <a16:colId xmlns:a16="http://schemas.microsoft.com/office/drawing/2014/main" val="602065470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1220642007"/>
                    </a:ext>
                  </a:extLst>
                </a:gridCol>
                <a:gridCol w="1472345">
                  <a:extLst>
                    <a:ext uri="{9D8B030D-6E8A-4147-A177-3AD203B41FA5}">
                      <a16:colId xmlns:a16="http://schemas.microsoft.com/office/drawing/2014/main" val="1022298259"/>
                    </a:ext>
                  </a:extLst>
                </a:gridCol>
              </a:tblGrid>
              <a:tr h="489584"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6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-12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Average (SD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-12 Difference of DASH 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248042"/>
                  </a:ext>
                </a:extLst>
              </a:tr>
              <a:tr h="20672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ostoperative CMAP &lt; 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.9 (11.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.7 (17.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.6 (6.0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5447652"/>
                  </a:ext>
                </a:extLst>
              </a:tr>
              <a:tr h="206729"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Postoperative CMAP </a:t>
                      </a:r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9.0 (18.0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.9 (10.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.9 (21.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7695268"/>
                  </a:ext>
                </a:extLst>
              </a:tr>
            </a:tbl>
          </a:graphicData>
        </a:graphic>
      </p:graphicFrame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40658DFE-7238-4E0E-97C4-AF996F45B75E}"/>
              </a:ext>
            </a:extLst>
          </p:cNvPr>
          <p:cNvSpPr txBox="1"/>
          <p:nvPr/>
        </p:nvSpPr>
        <p:spPr>
          <a:xfrm>
            <a:off x="190634" y="967167"/>
            <a:ext cx="5761812" cy="681992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</a:t>
            </a:r>
          </a:p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average difference of grip strength and DASH between  two groups divided by the lower limit of 6 months postoperative CMAP amplitudes</a:t>
            </a:r>
          </a:p>
        </p:txBody>
      </p:sp>
      <p:sp>
        <p:nvSpPr>
          <p:cNvPr id="8" name="テキスト ボックス 2">
            <a:extLst>
              <a:ext uri="{FF2B5EF4-FFF2-40B4-BE49-F238E27FC236}">
                <a16:creationId xmlns:a16="http://schemas.microsoft.com/office/drawing/2014/main" id="{087A5378-5344-4DA2-A2FE-E6B8980F742D}"/>
              </a:ext>
            </a:extLst>
          </p:cNvPr>
          <p:cNvSpPr txBox="1"/>
          <p:nvPr/>
        </p:nvSpPr>
        <p:spPr>
          <a:xfrm>
            <a:off x="190634" y="3805005"/>
            <a:ext cx="2855594" cy="275590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/>
              <a:t>* </a:t>
            </a:r>
            <a:r>
              <a:rPr lang="en-US" altLang="ja-JP" sz="1050" i="1" dirty="0">
                <a:latin typeface="Times" panose="02020603050405020304" pitchFamily="18" charset="0"/>
                <a:cs typeface="Times" panose="02020603050405020304" pitchFamily="18" charset="0"/>
              </a:rPr>
              <a:t>P</a:t>
            </a:r>
            <a:r>
              <a:rPr lang="en-US" altLang="ja-JP" sz="1050" dirty="0">
                <a:latin typeface="Times" panose="02020603050405020304" pitchFamily="18" charset="0"/>
                <a:cs typeface="Times" panose="02020603050405020304" pitchFamily="18" charset="0"/>
              </a:rPr>
              <a:t>&lt;0.05,**</a:t>
            </a:r>
            <a:r>
              <a:rPr lang="en-US" altLang="ja-JP" sz="1050" i="1" dirty="0">
                <a:latin typeface="Times" panose="02020603050405020304" pitchFamily="18" charset="0"/>
                <a:cs typeface="Times" panose="02020603050405020304" pitchFamily="18" charset="0"/>
              </a:rPr>
              <a:t>P</a:t>
            </a:r>
            <a:r>
              <a:rPr lang="en-US" altLang="ja-JP" sz="1050" dirty="0">
                <a:latin typeface="Times" panose="02020603050405020304" pitchFamily="18" charset="0"/>
                <a:cs typeface="Times" panose="02020603050405020304" pitchFamily="18" charset="0"/>
              </a:rPr>
              <a:t>&lt;0.01; </a:t>
            </a:r>
            <a:r>
              <a:rPr lang="en-US" altLang="ja-JP" sz="1050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nn–Whitney </a:t>
            </a:r>
            <a:r>
              <a:rPr lang="en-US" altLang="ja-JP" sz="1050" b="1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en-US" altLang="ja-JP" sz="1050" dirty="0">
                <a:solidFill>
                  <a:srgbClr val="202124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test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05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9879439"/>
      </p:ext>
    </p:extLst>
  </p:cSld>
  <p:clrMapOvr>
    <a:masterClrMapping/>
  </p:clrMapOvr>
</p:sld>
</file>

<file path=ppt/theme/theme1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デザインの設定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316</Words>
  <Application>Microsoft Office PowerPoint</Application>
  <PresentationFormat>A4 210 x 297 mm</PresentationFormat>
  <Paragraphs>6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デザインの設定</vt:lpstr>
      <vt:lpstr>1_デザインの設定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勢 真人</dc:creator>
  <cp:lastModifiedBy>伊勢 真人</cp:lastModifiedBy>
  <cp:revision>1</cp:revision>
  <dcterms:created xsi:type="dcterms:W3CDTF">2021-07-19T10:50:45Z</dcterms:created>
  <dcterms:modified xsi:type="dcterms:W3CDTF">2021-07-19T10:51:52Z</dcterms:modified>
</cp:coreProperties>
</file>